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421647843705144E-2"/>
          <c:y val="5.0314465408805034E-2"/>
          <c:w val="0.87630971442136141"/>
          <c:h val="0.827933244193532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yto!$K$48:$L$48</c:f>
              <c:strCache>
                <c:ptCount val="2"/>
                <c:pt idx="0">
                  <c:v>avg</c:v>
                </c:pt>
                <c:pt idx="1">
                  <c:v>No coatin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yto!$M$55:$O$55</c:f>
                <c:numCache>
                  <c:formatCode>General</c:formatCode>
                  <c:ptCount val="3"/>
                  <c:pt idx="0">
                    <c:v>6.8090324183169351</c:v>
                  </c:pt>
                  <c:pt idx="1">
                    <c:v>10.683813134736825</c:v>
                  </c:pt>
                  <c:pt idx="2">
                    <c:v>10.245873881853859</c:v>
                  </c:pt>
                </c:numCache>
              </c:numRef>
            </c:plus>
            <c:minus>
              <c:numRef>
                <c:f>cyto!$M$55:$O$55</c:f>
                <c:numCache>
                  <c:formatCode>General</c:formatCode>
                  <c:ptCount val="3"/>
                  <c:pt idx="0">
                    <c:v>6.8090324183169351</c:v>
                  </c:pt>
                  <c:pt idx="1">
                    <c:v>10.683813134736825</c:v>
                  </c:pt>
                  <c:pt idx="2">
                    <c:v>10.2458738818538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yto!$M$47:$O$47</c:f>
              <c:strCache>
                <c:ptCount val="3"/>
                <c:pt idx="0">
                  <c:v>TIL 014/F3</c:v>
                </c:pt>
                <c:pt idx="1">
                  <c:v>TIL F14/F4</c:v>
                </c:pt>
                <c:pt idx="2">
                  <c:v>TIL 052</c:v>
                </c:pt>
              </c:strCache>
            </c:strRef>
          </c:cat>
          <c:val>
            <c:numRef>
              <c:f>cyto!$M$48:$O$48</c:f>
              <c:numCache>
                <c:formatCode>0.00</c:formatCode>
                <c:ptCount val="3"/>
                <c:pt idx="0">
                  <c:v>6.9136614664575378</c:v>
                </c:pt>
                <c:pt idx="1">
                  <c:v>50.449728376032368</c:v>
                </c:pt>
                <c:pt idx="2">
                  <c:v>29.4434720955363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C9-49CD-92FC-F3F764DEC928}"/>
            </c:ext>
          </c:extLst>
        </c:ser>
        <c:ser>
          <c:idx val="1"/>
          <c:order val="1"/>
          <c:tx>
            <c:strRef>
              <c:f>cyto!$K$49:$L$49</c:f>
              <c:strCache>
                <c:ptCount val="2"/>
                <c:pt idx="0">
                  <c:v>avg</c:v>
                </c:pt>
                <c:pt idx="1">
                  <c:v>CCL21+ICAM1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yto!$M$56:$O$56</c:f>
                <c:numCache>
                  <c:formatCode>General</c:formatCode>
                  <c:ptCount val="3"/>
                  <c:pt idx="0">
                    <c:v>3.344495500920369</c:v>
                  </c:pt>
                  <c:pt idx="1">
                    <c:v>13.343446752451117</c:v>
                  </c:pt>
                  <c:pt idx="2">
                    <c:v>38.632833135862896</c:v>
                  </c:pt>
                </c:numCache>
              </c:numRef>
            </c:plus>
            <c:minus>
              <c:numRef>
                <c:f>cyto!$M$56:$O$56</c:f>
                <c:numCache>
                  <c:formatCode>General</c:formatCode>
                  <c:ptCount val="3"/>
                  <c:pt idx="0">
                    <c:v>3.344495500920369</c:v>
                  </c:pt>
                  <c:pt idx="1">
                    <c:v>13.343446752451117</c:v>
                  </c:pt>
                  <c:pt idx="2">
                    <c:v>38.6328331358628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yto!$M$47:$O$47</c:f>
              <c:strCache>
                <c:ptCount val="3"/>
                <c:pt idx="0">
                  <c:v>TIL 014/F3</c:v>
                </c:pt>
                <c:pt idx="1">
                  <c:v>TIL F14/F4</c:v>
                </c:pt>
                <c:pt idx="2">
                  <c:v>TIL 052</c:v>
                </c:pt>
              </c:strCache>
            </c:strRef>
          </c:cat>
          <c:val>
            <c:numRef>
              <c:f>cyto!$M$49:$O$49</c:f>
              <c:numCache>
                <c:formatCode>0.00</c:formatCode>
                <c:ptCount val="3"/>
                <c:pt idx="0">
                  <c:v>21.848476111947232</c:v>
                </c:pt>
                <c:pt idx="1">
                  <c:v>74.091560416453333</c:v>
                </c:pt>
                <c:pt idx="2">
                  <c:v>36.4530870398946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FC9-49CD-92FC-F3F764DEC9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7296280"/>
        <c:axId val="367295296"/>
      </c:barChart>
      <c:catAx>
        <c:axId val="367296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he-IL"/>
          </a:p>
        </c:txPr>
        <c:crossAx val="367295296"/>
        <c:crosses val="autoZero"/>
        <c:auto val="1"/>
        <c:lblAlgn val="ctr"/>
        <c:lblOffset val="100"/>
        <c:noMultiLvlLbl val="0"/>
      </c:catAx>
      <c:valAx>
        <c:axId val="367295296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he-IL"/>
          </a:p>
        </c:txPr>
        <c:crossAx val="367296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47512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38808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22179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45806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68225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82432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93011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28968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81835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6950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84041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69920C-22BD-41D3-B9AE-699D22D20A64}" type="datetimeFigureOut">
              <a:rPr lang="he-IL" smtClean="0"/>
              <a:t>ג'/שבט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94164-311B-43ED-A241-015543483FC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15645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208579" y="1361620"/>
            <a:ext cx="4427284" cy="2524125"/>
            <a:chOff x="266769" y="748005"/>
            <a:chExt cx="4427284" cy="2524125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58958852"/>
                </p:ext>
              </p:extLst>
            </p:nvPr>
          </p:nvGraphicFramePr>
          <p:xfrm>
            <a:off x="498291" y="748005"/>
            <a:ext cx="4195762" cy="25241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152737" y="1649675"/>
              <a:ext cx="1116011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200" dirty="0" smtClean="0"/>
                <a:t>% </a:t>
              </a:r>
              <a:r>
                <a:rPr lang="en-US" sz="1200" dirty="0" smtClean="0">
                  <a:latin typeface="Arial" panose="020B0604020202020204" pitchFamily="34" charset="0"/>
                </a:rPr>
                <a:t>Cytotoxicity</a:t>
              </a:r>
              <a:endParaRPr lang="he-IL" sz="1200" dirty="0">
                <a:latin typeface="Arial" panose="020B0604020202020204" pitchFamily="34" charset="0"/>
              </a:endParaRP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1324947" y="2202025"/>
              <a:ext cx="289249" cy="261610"/>
              <a:chOff x="1250302" y="1950098"/>
              <a:chExt cx="289249" cy="261610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1250302" y="1950098"/>
                <a:ext cx="289249" cy="261610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he-IL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" name="Straight Connector 7"/>
              <p:cNvCxnSpPr/>
              <p:nvPr/>
            </p:nvCxnSpPr>
            <p:spPr>
              <a:xfrm>
                <a:off x="1250302" y="2139022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oup 10"/>
            <p:cNvGrpSpPr/>
            <p:nvPr/>
          </p:nvGrpSpPr>
          <p:grpSpPr>
            <a:xfrm>
              <a:off x="2590679" y="802668"/>
              <a:ext cx="289249" cy="261610"/>
              <a:chOff x="1250302" y="1950098"/>
              <a:chExt cx="289249" cy="261610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1250302" y="1950098"/>
                <a:ext cx="289249" cy="261610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he-IL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1250302" y="2139022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13"/>
            <p:cNvGrpSpPr/>
            <p:nvPr/>
          </p:nvGrpSpPr>
          <p:grpSpPr>
            <a:xfrm>
              <a:off x="3834759" y="1036285"/>
              <a:ext cx="354685" cy="261610"/>
              <a:chOff x="1222309" y="1922105"/>
              <a:chExt cx="354685" cy="261610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1222309" y="1922105"/>
                <a:ext cx="354685" cy="261610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he-IL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" name="Straight Connector 15"/>
              <p:cNvCxnSpPr/>
              <p:nvPr/>
            </p:nvCxnSpPr>
            <p:spPr>
              <a:xfrm>
                <a:off x="1250302" y="2139022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7" name="Rectangle 16"/>
          <p:cNvSpPr/>
          <p:nvPr/>
        </p:nvSpPr>
        <p:spPr>
          <a:xfrm>
            <a:off x="220602" y="183097"/>
            <a:ext cx="1142623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Figure 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ffect of the CCL21-ICAM1 SIN on TIL-mediated cytotoxicity towards autologous cancer cells. TIL were co-cultured with autologous melanoma cells overnight, at 37°C and at an effector to target ratio of 1:1. The percentage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ytotoxicit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as recorded for three TI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mpl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y LDH assay. Experiments were performed in triplicates, and the results are presented as mean ± standard deviation (SD)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he-I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9073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1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he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blic Maabadot Melanoma 26</dc:creator>
  <cp:lastModifiedBy>Public Maabadot Melanoma 26</cp:lastModifiedBy>
  <cp:revision>6</cp:revision>
  <dcterms:created xsi:type="dcterms:W3CDTF">2023-01-23T09:45:28Z</dcterms:created>
  <dcterms:modified xsi:type="dcterms:W3CDTF">2023-01-25T08:29:50Z</dcterms:modified>
</cp:coreProperties>
</file>